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57" r:id="rId2"/>
  </p:sldIdLst>
  <p:sldSz cx="6858000" cy="9144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51" d="100"/>
          <a:sy n="51" d="100"/>
        </p:scale>
        <p:origin x="2340" y="9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7" Type="http://schemas.microsoft.com/office/2016/11/relationships/changesInfo" Target="changesInfos/changesInfo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OKAGAWA Tomohiro" userId="d74b3e309c52a267" providerId="LiveId" clId="{5886FCBB-F41C-42F7-933B-7BDE3AE3053C}"/>
    <pc:docChg chg="undo custSel modSld">
      <pc:chgData name="OKAGAWA Tomohiro" userId="d74b3e309c52a267" providerId="LiveId" clId="{5886FCBB-F41C-42F7-933B-7BDE3AE3053C}" dt="2021-12-28T02:15:46.007" v="772" actId="1038"/>
      <pc:docMkLst>
        <pc:docMk/>
      </pc:docMkLst>
      <pc:sldChg chg="addSp modSp mod">
        <pc:chgData name="OKAGAWA Tomohiro" userId="d74b3e309c52a267" providerId="LiveId" clId="{5886FCBB-F41C-42F7-933B-7BDE3AE3053C}" dt="2021-12-28T02:15:46.007" v="772" actId="1038"/>
        <pc:sldMkLst>
          <pc:docMk/>
          <pc:sldMk cId="2879998273" sldId="256"/>
        </pc:sldMkLst>
        <pc:spChg chg="add mod">
          <ac:chgData name="OKAGAWA Tomohiro" userId="d74b3e309c52a267" providerId="LiveId" clId="{5886FCBB-F41C-42F7-933B-7BDE3AE3053C}" dt="2021-12-28T01:56:57.007" v="38" actId="1076"/>
          <ac:spMkLst>
            <pc:docMk/>
            <pc:sldMk cId="2879998273" sldId="256"/>
            <ac:spMk id="3" creationId="{3C71BA40-4C5F-4E3E-9FDF-10D59AB43C66}"/>
          </ac:spMkLst>
        </pc:spChg>
        <pc:graphicFrameChg chg="mod modGraphic">
          <ac:chgData name="OKAGAWA Tomohiro" userId="d74b3e309c52a267" providerId="LiveId" clId="{5886FCBB-F41C-42F7-933B-7BDE3AE3053C}" dt="2021-12-28T02:15:46.007" v="772" actId="1038"/>
          <ac:graphicFrameMkLst>
            <pc:docMk/>
            <pc:sldMk cId="2879998273" sldId="256"/>
            <ac:graphicFrameMk id="5" creationId="{28AA4524-C1F8-4974-A5E6-93C4C8CE70A8}"/>
          </ac:graphicFrameMkLst>
        </pc:graphicFrameChg>
      </pc:sldChg>
      <pc:sldChg chg="addSp modSp mod">
        <pc:chgData name="OKAGAWA Tomohiro" userId="d74b3e309c52a267" providerId="LiveId" clId="{5886FCBB-F41C-42F7-933B-7BDE3AE3053C}" dt="2021-12-28T02:15:39.635" v="763" actId="12788"/>
        <pc:sldMkLst>
          <pc:docMk/>
          <pc:sldMk cId="2176500321" sldId="257"/>
        </pc:sldMkLst>
        <pc:spChg chg="mod">
          <ac:chgData name="OKAGAWA Tomohiro" userId="d74b3e309c52a267" providerId="LiveId" clId="{5886FCBB-F41C-42F7-933B-7BDE3AE3053C}" dt="2021-12-28T01:59:20.726" v="105" actId="552"/>
          <ac:spMkLst>
            <pc:docMk/>
            <pc:sldMk cId="2176500321" sldId="257"/>
            <ac:spMk id="8" creationId="{CECC3651-6356-42BA-90D4-D53D8AF637D3}"/>
          </ac:spMkLst>
        </pc:spChg>
        <pc:spChg chg="mod">
          <ac:chgData name="OKAGAWA Tomohiro" userId="d74b3e309c52a267" providerId="LiveId" clId="{5886FCBB-F41C-42F7-933B-7BDE3AE3053C}" dt="2021-12-28T01:59:28.193" v="107" actId="14100"/>
          <ac:spMkLst>
            <pc:docMk/>
            <pc:sldMk cId="2176500321" sldId="257"/>
            <ac:spMk id="9" creationId="{847F998F-4C07-4B5A-A9F3-01507E6D6A75}"/>
          </ac:spMkLst>
        </pc:spChg>
        <pc:spChg chg="mod">
          <ac:chgData name="OKAGAWA Tomohiro" userId="d74b3e309c52a267" providerId="LiveId" clId="{5886FCBB-F41C-42F7-933B-7BDE3AE3053C}" dt="2021-12-28T01:59:20.726" v="105" actId="552"/>
          <ac:spMkLst>
            <pc:docMk/>
            <pc:sldMk cId="2176500321" sldId="257"/>
            <ac:spMk id="10" creationId="{FDE252EE-D3A8-4DB5-8025-9A869134AB24}"/>
          </ac:spMkLst>
        </pc:spChg>
        <pc:spChg chg="mod">
          <ac:chgData name="OKAGAWA Tomohiro" userId="d74b3e309c52a267" providerId="LiveId" clId="{5886FCBB-F41C-42F7-933B-7BDE3AE3053C}" dt="2021-12-28T01:59:24.992" v="106" actId="552"/>
          <ac:spMkLst>
            <pc:docMk/>
            <pc:sldMk cId="2176500321" sldId="257"/>
            <ac:spMk id="11" creationId="{182492F5-D548-4006-A7D9-7D539CD3BF35}"/>
          </ac:spMkLst>
        </pc:spChg>
        <pc:spChg chg="add mod">
          <ac:chgData name="OKAGAWA Tomohiro" userId="d74b3e309c52a267" providerId="LiveId" clId="{5886FCBB-F41C-42F7-933B-7BDE3AE3053C}" dt="2021-12-28T02:15:39.635" v="763" actId="12788"/>
          <ac:spMkLst>
            <pc:docMk/>
            <pc:sldMk cId="2176500321" sldId="257"/>
            <ac:spMk id="12" creationId="{388C4F0B-C68F-487B-8066-CF13BA86AD47}"/>
          </ac:spMkLst>
        </pc:spChg>
      </pc:sldChg>
      <pc:sldChg chg="addSp modSp mod">
        <pc:chgData name="OKAGAWA Tomohiro" userId="d74b3e309c52a267" providerId="LiveId" clId="{5886FCBB-F41C-42F7-933B-7BDE3AE3053C}" dt="2021-12-28T02:15:34.905" v="762" actId="12788"/>
        <pc:sldMkLst>
          <pc:docMk/>
          <pc:sldMk cId="3092454316" sldId="258"/>
        </pc:sldMkLst>
        <pc:spChg chg="mod">
          <ac:chgData name="OKAGAWA Tomohiro" userId="d74b3e309c52a267" providerId="LiveId" clId="{5886FCBB-F41C-42F7-933B-7BDE3AE3053C}" dt="2021-12-28T02:02:50.654" v="216" actId="1035"/>
          <ac:spMkLst>
            <pc:docMk/>
            <pc:sldMk cId="3092454316" sldId="258"/>
            <ac:spMk id="5" creationId="{AD53BC56-9CD9-4537-BC22-509DD5F5CF28}"/>
          </ac:spMkLst>
        </pc:spChg>
        <pc:spChg chg="mod">
          <ac:chgData name="OKAGAWA Tomohiro" userId="d74b3e309c52a267" providerId="LiveId" clId="{5886FCBB-F41C-42F7-933B-7BDE3AE3053C}" dt="2021-12-28T02:02:50.654" v="216" actId="1035"/>
          <ac:spMkLst>
            <pc:docMk/>
            <pc:sldMk cId="3092454316" sldId="258"/>
            <ac:spMk id="7" creationId="{06A4BC64-B92B-46C5-B952-67D03CDA8590}"/>
          </ac:spMkLst>
        </pc:spChg>
        <pc:spChg chg="mod">
          <ac:chgData name="OKAGAWA Tomohiro" userId="d74b3e309c52a267" providerId="LiveId" clId="{5886FCBB-F41C-42F7-933B-7BDE3AE3053C}" dt="2021-12-28T02:10:28.233" v="569" actId="1035"/>
          <ac:spMkLst>
            <pc:docMk/>
            <pc:sldMk cId="3092454316" sldId="258"/>
            <ac:spMk id="9" creationId="{FC20F88B-779B-4B8E-9592-36D12D5934CB}"/>
          </ac:spMkLst>
        </pc:spChg>
        <pc:spChg chg="add mod">
          <ac:chgData name="OKAGAWA Tomohiro" userId="d74b3e309c52a267" providerId="LiveId" clId="{5886FCBB-F41C-42F7-933B-7BDE3AE3053C}" dt="2021-12-28T02:15:34.905" v="762" actId="12788"/>
          <ac:spMkLst>
            <pc:docMk/>
            <pc:sldMk cId="3092454316" sldId="258"/>
            <ac:spMk id="12" creationId="{03367787-1E0C-454E-9F9C-AD79F92BB878}"/>
          </ac:spMkLst>
        </pc:spChg>
        <pc:spChg chg="mod">
          <ac:chgData name="OKAGAWA Tomohiro" userId="d74b3e309c52a267" providerId="LiveId" clId="{5886FCBB-F41C-42F7-933B-7BDE3AE3053C}" dt="2021-12-28T02:10:28.233" v="569" actId="1035"/>
          <ac:spMkLst>
            <pc:docMk/>
            <pc:sldMk cId="3092454316" sldId="258"/>
            <ac:spMk id="13" creationId="{04C3066E-2124-4B3A-A634-79A06F62DFAE}"/>
          </ac:spMkLst>
        </pc:spChg>
        <pc:spChg chg="mod">
          <ac:chgData name="OKAGAWA Tomohiro" userId="d74b3e309c52a267" providerId="LiveId" clId="{5886FCBB-F41C-42F7-933B-7BDE3AE3053C}" dt="2021-12-28T02:10:28.233" v="569" actId="1035"/>
          <ac:spMkLst>
            <pc:docMk/>
            <pc:sldMk cId="3092454316" sldId="258"/>
            <ac:spMk id="15" creationId="{B5C586AD-A457-4A2F-B5AB-05587D506C9B}"/>
          </ac:spMkLst>
        </pc:spChg>
        <pc:graphicFrameChg chg="mod modGraphic">
          <ac:chgData name="OKAGAWA Tomohiro" userId="d74b3e309c52a267" providerId="LiveId" clId="{5886FCBB-F41C-42F7-933B-7BDE3AE3053C}" dt="2021-12-28T02:10:20.074" v="549" actId="14100"/>
          <ac:graphicFrameMkLst>
            <pc:docMk/>
            <pc:sldMk cId="3092454316" sldId="258"/>
            <ac:graphicFrameMk id="4" creationId="{51D5F3E7-2D88-4977-9F1F-E68466E57757}"/>
          </ac:graphicFrameMkLst>
        </pc:graphicFrameChg>
        <pc:graphicFrameChg chg="mod modGraphic">
          <ac:chgData name="OKAGAWA Tomohiro" userId="d74b3e309c52a267" providerId="LiveId" clId="{5886FCBB-F41C-42F7-933B-7BDE3AE3053C}" dt="2021-12-28T02:10:20.074" v="549" actId="14100"/>
          <ac:graphicFrameMkLst>
            <pc:docMk/>
            <pc:sldMk cId="3092454316" sldId="258"/>
            <ac:graphicFrameMk id="6" creationId="{8D9A3B75-ED18-42AC-BA85-8E4D135AE787}"/>
          </ac:graphicFrameMkLst>
        </pc:graphicFrameChg>
        <pc:graphicFrameChg chg="mod modGraphic">
          <ac:chgData name="OKAGAWA Tomohiro" userId="d74b3e309c52a267" providerId="LiveId" clId="{5886FCBB-F41C-42F7-933B-7BDE3AE3053C}" dt="2021-12-28T02:10:28.233" v="569" actId="1035"/>
          <ac:graphicFrameMkLst>
            <pc:docMk/>
            <pc:sldMk cId="3092454316" sldId="258"/>
            <ac:graphicFrameMk id="10" creationId="{2F66BED3-B3FF-4B8B-ADB5-60003887B286}"/>
          </ac:graphicFrameMkLst>
        </pc:graphicFrameChg>
        <pc:graphicFrameChg chg="mod modGraphic">
          <ac:chgData name="OKAGAWA Tomohiro" userId="d74b3e309c52a267" providerId="LiveId" clId="{5886FCBB-F41C-42F7-933B-7BDE3AE3053C}" dt="2021-12-28T02:10:28.233" v="569" actId="1035"/>
          <ac:graphicFrameMkLst>
            <pc:docMk/>
            <pc:sldMk cId="3092454316" sldId="258"/>
            <ac:graphicFrameMk id="11" creationId="{DF1EE0C2-391D-4AF4-848F-B89D1098CCD9}"/>
          </ac:graphicFrameMkLst>
        </pc:graphicFrameChg>
        <pc:graphicFrameChg chg="mod modGraphic">
          <ac:chgData name="OKAGAWA Tomohiro" userId="d74b3e309c52a267" providerId="LiveId" clId="{5886FCBB-F41C-42F7-933B-7BDE3AE3053C}" dt="2021-12-28T02:10:28.233" v="569" actId="1035"/>
          <ac:graphicFrameMkLst>
            <pc:docMk/>
            <pc:sldMk cId="3092454316" sldId="258"/>
            <ac:graphicFrameMk id="14" creationId="{633FAB34-FE47-4EF9-B7B0-908C0DEE818E}"/>
          </ac:graphicFrameMkLst>
        </pc:graphicFrameChg>
      </pc:sldChg>
      <pc:sldChg chg="addSp modSp mod">
        <pc:chgData name="OKAGAWA Tomohiro" userId="d74b3e309c52a267" providerId="LiveId" clId="{5886FCBB-F41C-42F7-933B-7BDE3AE3053C}" dt="2021-12-28T02:15:30.670" v="761" actId="12788"/>
        <pc:sldMkLst>
          <pc:docMk/>
          <pc:sldMk cId="4162683584" sldId="259"/>
        </pc:sldMkLst>
        <pc:spChg chg="mod">
          <ac:chgData name="OKAGAWA Tomohiro" userId="d74b3e309c52a267" providerId="LiveId" clId="{5886FCBB-F41C-42F7-933B-7BDE3AE3053C}" dt="2021-12-28T02:14:40.539" v="744" actId="552"/>
          <ac:spMkLst>
            <pc:docMk/>
            <pc:sldMk cId="4162683584" sldId="259"/>
            <ac:spMk id="10" creationId="{FDE252EE-D3A8-4DB5-8025-9A869134AB24}"/>
          </ac:spMkLst>
        </pc:spChg>
        <pc:spChg chg="add mod">
          <ac:chgData name="OKAGAWA Tomohiro" userId="d74b3e309c52a267" providerId="LiveId" clId="{5886FCBB-F41C-42F7-933B-7BDE3AE3053C}" dt="2021-12-28T02:15:30.670" v="761" actId="12788"/>
          <ac:spMkLst>
            <pc:docMk/>
            <pc:sldMk cId="4162683584" sldId="259"/>
            <ac:spMk id="11" creationId="{110936BD-A3DB-4F7C-AF31-3592F0EA6EB6}"/>
          </ac:spMkLst>
        </pc:spChg>
        <pc:spChg chg="mod">
          <ac:chgData name="OKAGAWA Tomohiro" userId="d74b3e309c52a267" providerId="LiveId" clId="{5886FCBB-F41C-42F7-933B-7BDE3AE3053C}" dt="2021-12-28T02:14:40.539" v="744" actId="552"/>
          <ac:spMkLst>
            <pc:docMk/>
            <pc:sldMk cId="4162683584" sldId="259"/>
            <ac:spMk id="15" creationId="{917B32FB-9B87-4C4D-AA9B-FFC3E39069AA}"/>
          </ac:spMkLst>
        </pc:spChg>
        <pc:spChg chg="mod">
          <ac:chgData name="OKAGAWA Tomohiro" userId="d74b3e309c52a267" providerId="LiveId" clId="{5886FCBB-F41C-42F7-933B-7BDE3AE3053C}" dt="2021-12-28T02:14:35.646" v="743" actId="552"/>
          <ac:spMkLst>
            <pc:docMk/>
            <pc:sldMk cId="4162683584" sldId="259"/>
            <ac:spMk id="16" creationId="{AD5C1B79-42DB-4284-B402-5406663A737A}"/>
          </ac:spMkLst>
        </pc:spChg>
        <pc:spChg chg="mod">
          <ac:chgData name="OKAGAWA Tomohiro" userId="d74b3e309c52a267" providerId="LiveId" clId="{5886FCBB-F41C-42F7-933B-7BDE3AE3053C}" dt="2021-12-28T02:14:35.646" v="743" actId="552"/>
          <ac:spMkLst>
            <pc:docMk/>
            <pc:sldMk cId="4162683584" sldId="259"/>
            <ac:spMk id="17" creationId="{D41489B0-161B-4390-B14D-AF376C68EF15}"/>
          </ac:spMkLst>
        </pc:sp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27BCE0-7016-4323-923E-C5BFC6B93F60}" type="datetimeFigureOut">
              <a:rPr kumimoji="1" lang="ja-JP" altLang="en-US" smtClean="0"/>
              <a:t>2022/2/1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B34395-28C6-416D-8A19-16A0FD6E39E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9998375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27BCE0-7016-4323-923E-C5BFC6B93F60}" type="datetimeFigureOut">
              <a:rPr kumimoji="1" lang="ja-JP" altLang="en-US" smtClean="0"/>
              <a:t>2022/2/1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B34395-28C6-416D-8A19-16A0FD6E39E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0215813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27BCE0-7016-4323-923E-C5BFC6B93F60}" type="datetimeFigureOut">
              <a:rPr kumimoji="1" lang="ja-JP" altLang="en-US" smtClean="0"/>
              <a:t>2022/2/1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B34395-28C6-416D-8A19-16A0FD6E39E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6827022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27BCE0-7016-4323-923E-C5BFC6B93F60}" type="datetimeFigureOut">
              <a:rPr kumimoji="1" lang="ja-JP" altLang="en-US" smtClean="0"/>
              <a:t>2022/2/1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B34395-28C6-416D-8A19-16A0FD6E39E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2891743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27BCE0-7016-4323-923E-C5BFC6B93F60}" type="datetimeFigureOut">
              <a:rPr kumimoji="1" lang="ja-JP" altLang="en-US" smtClean="0"/>
              <a:t>2022/2/1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B34395-28C6-416D-8A19-16A0FD6E39E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0220713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27BCE0-7016-4323-923E-C5BFC6B93F60}" type="datetimeFigureOut">
              <a:rPr kumimoji="1" lang="ja-JP" altLang="en-US" smtClean="0"/>
              <a:t>2022/2/15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B34395-28C6-416D-8A19-16A0FD6E39E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8597912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27BCE0-7016-4323-923E-C5BFC6B93F60}" type="datetimeFigureOut">
              <a:rPr kumimoji="1" lang="ja-JP" altLang="en-US" smtClean="0"/>
              <a:t>2022/2/15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B34395-28C6-416D-8A19-16A0FD6E39E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8327246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27BCE0-7016-4323-923E-C5BFC6B93F60}" type="datetimeFigureOut">
              <a:rPr kumimoji="1" lang="ja-JP" altLang="en-US" smtClean="0"/>
              <a:t>2022/2/15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B34395-28C6-416D-8A19-16A0FD6E39E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035194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27BCE0-7016-4323-923E-C5BFC6B93F60}" type="datetimeFigureOut">
              <a:rPr kumimoji="1" lang="ja-JP" altLang="en-US" smtClean="0"/>
              <a:t>2022/2/15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B34395-28C6-416D-8A19-16A0FD6E39E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8575037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27BCE0-7016-4323-923E-C5BFC6B93F60}" type="datetimeFigureOut">
              <a:rPr kumimoji="1" lang="ja-JP" altLang="en-US" smtClean="0"/>
              <a:t>2022/2/15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B34395-28C6-416D-8A19-16A0FD6E39E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2561148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27BCE0-7016-4323-923E-C5BFC6B93F60}" type="datetimeFigureOut">
              <a:rPr kumimoji="1" lang="ja-JP" altLang="en-US" smtClean="0"/>
              <a:t>2022/2/15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B34395-28C6-416D-8A19-16A0FD6E39E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1841135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A27BCE0-7016-4323-923E-C5BFC6B93F60}" type="datetimeFigureOut">
              <a:rPr kumimoji="1" lang="ja-JP" altLang="en-US" smtClean="0"/>
              <a:t>2022/2/1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AB34395-28C6-416D-8A19-16A0FD6E39E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7208166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" name="表 2">
            <a:extLst>
              <a:ext uri="{FF2B5EF4-FFF2-40B4-BE49-F238E27FC236}">
                <a16:creationId xmlns:a16="http://schemas.microsoft.com/office/drawing/2014/main" id="{985DB0FA-65BE-494C-B615-A08171FD9ED9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752408251"/>
              </p:ext>
            </p:extLst>
          </p:nvPr>
        </p:nvGraphicFramePr>
        <p:xfrm>
          <a:off x="771605" y="832324"/>
          <a:ext cx="2133600" cy="1612900"/>
        </p:xfrm>
        <a:graphic>
          <a:graphicData uri="http://schemas.openxmlformats.org/drawingml/2006/table">
            <a:tbl>
              <a:tblPr/>
              <a:tblGrid>
                <a:gridCol w="812800">
                  <a:extLst>
                    <a:ext uri="{9D8B030D-6E8A-4147-A177-3AD203B41FA5}">
                      <a16:colId xmlns:a16="http://schemas.microsoft.com/office/drawing/2014/main" val="3389080055"/>
                    </a:ext>
                  </a:extLst>
                </a:gridCol>
                <a:gridCol w="660400">
                  <a:extLst>
                    <a:ext uri="{9D8B030D-6E8A-4147-A177-3AD203B41FA5}">
                      <a16:colId xmlns:a16="http://schemas.microsoft.com/office/drawing/2014/main" val="1456764881"/>
                    </a:ext>
                  </a:extLst>
                </a:gridCol>
                <a:gridCol w="660400">
                  <a:extLst>
                    <a:ext uri="{9D8B030D-6E8A-4147-A177-3AD203B41FA5}">
                      <a16:colId xmlns:a16="http://schemas.microsoft.com/office/drawing/2014/main" val="221063778"/>
                    </a:ext>
                  </a:extLst>
                </a:gridCol>
              </a:tblGrid>
              <a:tr h="23495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Animal # 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Pre</a:t>
                      </a:r>
                    </a:p>
                  </a:txBody>
                  <a:tcPr marL="6350" marR="6350" marT="635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Day 0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447106219"/>
                  </a:ext>
                </a:extLst>
              </a:tr>
              <a:tr h="234950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1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541.0</a:t>
                      </a:r>
                    </a:p>
                  </a:txBody>
                  <a:tcPr marL="6350" marR="6350" marT="635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1974.2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005537474"/>
                  </a:ext>
                </a:extLst>
              </a:tr>
              <a:tr h="228600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2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482.6</a:t>
                      </a:r>
                    </a:p>
                  </a:txBody>
                  <a:tcPr marL="6350" marR="6350" marT="635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1627.6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513842795"/>
                  </a:ext>
                </a:extLst>
              </a:tr>
              <a:tr h="228600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3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358.7</a:t>
                      </a:r>
                    </a:p>
                  </a:txBody>
                  <a:tcPr marL="6350" marR="6350" marT="635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1387.7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676887149"/>
                  </a:ext>
                </a:extLst>
              </a:tr>
              <a:tr h="228600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4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295.9</a:t>
                      </a:r>
                    </a:p>
                  </a:txBody>
                  <a:tcPr marL="6350" marR="6350" marT="635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2393.5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484391562"/>
                  </a:ext>
                </a:extLst>
              </a:tr>
              <a:tr h="228600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5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524.8</a:t>
                      </a:r>
                    </a:p>
                  </a:txBody>
                  <a:tcPr marL="6350" marR="6350" marT="635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1098.6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891700680"/>
                  </a:ext>
                </a:extLst>
              </a:tr>
              <a:tr h="22860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Average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440.6</a:t>
                      </a:r>
                    </a:p>
                  </a:txBody>
                  <a:tcPr marL="6350" marR="6350" marT="635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1696.3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767051133"/>
                  </a:ext>
                </a:extLst>
              </a:tr>
            </a:tbl>
          </a:graphicData>
        </a:graphic>
      </p:graphicFrame>
      <p:graphicFrame>
        <p:nvGraphicFramePr>
          <p:cNvPr id="4" name="表 3">
            <a:extLst>
              <a:ext uri="{FF2B5EF4-FFF2-40B4-BE49-F238E27FC236}">
                <a16:creationId xmlns:a16="http://schemas.microsoft.com/office/drawing/2014/main" id="{DDB23294-E183-4C46-B7EF-9626F768FB90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494068332"/>
              </p:ext>
            </p:extLst>
          </p:nvPr>
        </p:nvGraphicFramePr>
        <p:xfrm>
          <a:off x="3837535" y="832324"/>
          <a:ext cx="2133600" cy="1612900"/>
        </p:xfrm>
        <a:graphic>
          <a:graphicData uri="http://schemas.openxmlformats.org/drawingml/2006/table">
            <a:tbl>
              <a:tblPr/>
              <a:tblGrid>
                <a:gridCol w="812800">
                  <a:extLst>
                    <a:ext uri="{9D8B030D-6E8A-4147-A177-3AD203B41FA5}">
                      <a16:colId xmlns:a16="http://schemas.microsoft.com/office/drawing/2014/main" val="792853984"/>
                    </a:ext>
                  </a:extLst>
                </a:gridCol>
                <a:gridCol w="660400">
                  <a:extLst>
                    <a:ext uri="{9D8B030D-6E8A-4147-A177-3AD203B41FA5}">
                      <a16:colId xmlns:a16="http://schemas.microsoft.com/office/drawing/2014/main" val="4075350844"/>
                    </a:ext>
                  </a:extLst>
                </a:gridCol>
                <a:gridCol w="660400">
                  <a:extLst>
                    <a:ext uri="{9D8B030D-6E8A-4147-A177-3AD203B41FA5}">
                      <a16:colId xmlns:a16="http://schemas.microsoft.com/office/drawing/2014/main" val="289542616"/>
                    </a:ext>
                  </a:extLst>
                </a:gridCol>
              </a:tblGrid>
              <a:tr h="23495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Animal # 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Pre</a:t>
                      </a:r>
                    </a:p>
                  </a:txBody>
                  <a:tcPr marL="6350" marR="6350" marT="635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Day 0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44161947"/>
                  </a:ext>
                </a:extLst>
              </a:tr>
              <a:tr h="234950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1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8454.7</a:t>
                      </a:r>
                    </a:p>
                  </a:txBody>
                  <a:tcPr marL="6350" marR="6350" marT="635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190.3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016018140"/>
                  </a:ext>
                </a:extLst>
              </a:tr>
              <a:tr h="228600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2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1564.7</a:t>
                      </a:r>
                    </a:p>
                  </a:txBody>
                  <a:tcPr marL="6350" marR="6350" marT="635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1131.4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19060060"/>
                  </a:ext>
                </a:extLst>
              </a:tr>
              <a:tr h="228600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3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3262.8</a:t>
                      </a:r>
                    </a:p>
                  </a:txBody>
                  <a:tcPr marL="6350" marR="6350" marT="635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540.0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422852130"/>
                  </a:ext>
                </a:extLst>
              </a:tr>
              <a:tr h="228600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4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8181.4</a:t>
                      </a:r>
                    </a:p>
                  </a:txBody>
                  <a:tcPr marL="6350" marR="6350" marT="635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2739.1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030524906"/>
                  </a:ext>
                </a:extLst>
              </a:tr>
              <a:tr h="228600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5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2288.6</a:t>
                      </a:r>
                    </a:p>
                  </a:txBody>
                  <a:tcPr marL="6350" marR="6350" marT="635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1363.9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268537243"/>
                  </a:ext>
                </a:extLst>
              </a:tr>
              <a:tr h="22860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Average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4750.4</a:t>
                      </a:r>
                    </a:p>
                  </a:txBody>
                  <a:tcPr marL="6350" marR="6350" marT="635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1192.9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431879175"/>
                  </a:ext>
                </a:extLst>
              </a:tr>
            </a:tbl>
          </a:graphicData>
        </a:graphic>
      </p:graphicFrame>
      <p:graphicFrame>
        <p:nvGraphicFramePr>
          <p:cNvPr id="6" name="表 5">
            <a:extLst>
              <a:ext uri="{FF2B5EF4-FFF2-40B4-BE49-F238E27FC236}">
                <a16:creationId xmlns:a16="http://schemas.microsoft.com/office/drawing/2014/main" id="{3C504CB1-2367-4BAF-AC77-A51850CA9225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070058172"/>
              </p:ext>
            </p:extLst>
          </p:nvPr>
        </p:nvGraphicFramePr>
        <p:xfrm>
          <a:off x="771605" y="3590892"/>
          <a:ext cx="2133600" cy="1612900"/>
        </p:xfrm>
        <a:graphic>
          <a:graphicData uri="http://schemas.openxmlformats.org/drawingml/2006/table">
            <a:tbl>
              <a:tblPr/>
              <a:tblGrid>
                <a:gridCol w="812800">
                  <a:extLst>
                    <a:ext uri="{9D8B030D-6E8A-4147-A177-3AD203B41FA5}">
                      <a16:colId xmlns:a16="http://schemas.microsoft.com/office/drawing/2014/main" val="949426763"/>
                    </a:ext>
                  </a:extLst>
                </a:gridCol>
                <a:gridCol w="660400">
                  <a:extLst>
                    <a:ext uri="{9D8B030D-6E8A-4147-A177-3AD203B41FA5}">
                      <a16:colId xmlns:a16="http://schemas.microsoft.com/office/drawing/2014/main" val="2318326116"/>
                    </a:ext>
                  </a:extLst>
                </a:gridCol>
                <a:gridCol w="660400">
                  <a:extLst>
                    <a:ext uri="{9D8B030D-6E8A-4147-A177-3AD203B41FA5}">
                      <a16:colId xmlns:a16="http://schemas.microsoft.com/office/drawing/2014/main" val="2339018996"/>
                    </a:ext>
                  </a:extLst>
                </a:gridCol>
              </a:tblGrid>
              <a:tr h="23495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Animal # 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Pre</a:t>
                      </a:r>
                    </a:p>
                  </a:txBody>
                  <a:tcPr marL="6350" marR="6350" marT="635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Day 0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181332285"/>
                  </a:ext>
                </a:extLst>
              </a:tr>
              <a:tr h="234950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1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91.5</a:t>
                      </a:r>
                    </a:p>
                  </a:txBody>
                  <a:tcPr marL="6350" marR="6350" marT="635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23.1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616041987"/>
                  </a:ext>
                </a:extLst>
              </a:tr>
              <a:tr h="228600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2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27.4</a:t>
                      </a:r>
                    </a:p>
                  </a:txBody>
                  <a:tcPr marL="6350" marR="6350" marT="635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17.1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435941786"/>
                  </a:ext>
                </a:extLst>
              </a:tr>
              <a:tr h="228600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3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13.5</a:t>
                      </a:r>
                    </a:p>
                  </a:txBody>
                  <a:tcPr marL="6350" marR="6350" marT="635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0.3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147660569"/>
                  </a:ext>
                </a:extLst>
              </a:tr>
              <a:tr h="228600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4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432.5</a:t>
                      </a:r>
                    </a:p>
                  </a:txBody>
                  <a:tcPr marL="6350" marR="6350" marT="635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174.0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79279174"/>
                  </a:ext>
                </a:extLst>
              </a:tr>
              <a:tr h="228600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5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368.3</a:t>
                      </a:r>
                    </a:p>
                  </a:txBody>
                  <a:tcPr marL="6350" marR="6350" marT="635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11.8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1844618"/>
                  </a:ext>
                </a:extLst>
              </a:tr>
              <a:tr h="22860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Average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186.6</a:t>
                      </a:r>
                    </a:p>
                  </a:txBody>
                  <a:tcPr marL="6350" marR="6350" marT="635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45.3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640950063"/>
                  </a:ext>
                </a:extLst>
              </a:tr>
            </a:tbl>
          </a:graphicData>
        </a:graphic>
      </p:graphicFrame>
      <p:graphicFrame>
        <p:nvGraphicFramePr>
          <p:cNvPr id="7" name="表 6">
            <a:extLst>
              <a:ext uri="{FF2B5EF4-FFF2-40B4-BE49-F238E27FC236}">
                <a16:creationId xmlns:a16="http://schemas.microsoft.com/office/drawing/2014/main" id="{49EB3931-390C-4F4A-9F9E-20844EDA5159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24685299"/>
              </p:ext>
            </p:extLst>
          </p:nvPr>
        </p:nvGraphicFramePr>
        <p:xfrm>
          <a:off x="3837535" y="3590892"/>
          <a:ext cx="2133600" cy="1612900"/>
        </p:xfrm>
        <a:graphic>
          <a:graphicData uri="http://schemas.openxmlformats.org/drawingml/2006/table">
            <a:tbl>
              <a:tblPr/>
              <a:tblGrid>
                <a:gridCol w="812800">
                  <a:extLst>
                    <a:ext uri="{9D8B030D-6E8A-4147-A177-3AD203B41FA5}">
                      <a16:colId xmlns:a16="http://schemas.microsoft.com/office/drawing/2014/main" val="3215987685"/>
                    </a:ext>
                  </a:extLst>
                </a:gridCol>
                <a:gridCol w="660400">
                  <a:extLst>
                    <a:ext uri="{9D8B030D-6E8A-4147-A177-3AD203B41FA5}">
                      <a16:colId xmlns:a16="http://schemas.microsoft.com/office/drawing/2014/main" val="4236707564"/>
                    </a:ext>
                  </a:extLst>
                </a:gridCol>
                <a:gridCol w="660400">
                  <a:extLst>
                    <a:ext uri="{9D8B030D-6E8A-4147-A177-3AD203B41FA5}">
                      <a16:colId xmlns:a16="http://schemas.microsoft.com/office/drawing/2014/main" val="2755154819"/>
                    </a:ext>
                  </a:extLst>
                </a:gridCol>
              </a:tblGrid>
              <a:tr h="23495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Animal # 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Pre</a:t>
                      </a:r>
                    </a:p>
                  </a:txBody>
                  <a:tcPr marL="6350" marR="6350" marT="635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Day 0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646452983"/>
                  </a:ext>
                </a:extLst>
              </a:tr>
              <a:tr h="234950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1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158.6</a:t>
                      </a:r>
                    </a:p>
                  </a:txBody>
                  <a:tcPr marL="6350" marR="6350" marT="635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242.4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147775259"/>
                  </a:ext>
                </a:extLst>
              </a:tr>
              <a:tr h="228600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2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126.0</a:t>
                      </a:r>
                    </a:p>
                  </a:txBody>
                  <a:tcPr marL="6350" marR="6350" marT="635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268.5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056707338"/>
                  </a:ext>
                </a:extLst>
              </a:tr>
              <a:tr h="228600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3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264.9</a:t>
                      </a:r>
                    </a:p>
                  </a:txBody>
                  <a:tcPr marL="6350" marR="6350" marT="635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334.6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9635989"/>
                  </a:ext>
                </a:extLst>
              </a:tr>
              <a:tr h="228600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4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559.9</a:t>
                      </a:r>
                    </a:p>
                  </a:txBody>
                  <a:tcPr marL="6350" marR="6350" marT="635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1345.8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785052748"/>
                  </a:ext>
                </a:extLst>
              </a:tr>
              <a:tr h="228600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5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157.1</a:t>
                      </a:r>
                    </a:p>
                  </a:txBody>
                  <a:tcPr marL="6350" marR="6350" marT="635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763.2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245069301"/>
                  </a:ext>
                </a:extLst>
              </a:tr>
              <a:tr h="22860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Average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253.3</a:t>
                      </a:r>
                    </a:p>
                  </a:txBody>
                  <a:tcPr marL="6350" marR="6350" marT="635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590.9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67878117"/>
                  </a:ext>
                </a:extLst>
              </a:tr>
            </a:tbl>
          </a:graphicData>
        </a:graphic>
      </p:graphicFrame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CECC3651-6356-42BA-90D4-D53D8AF637D3}"/>
              </a:ext>
            </a:extLst>
          </p:cNvPr>
          <p:cNvSpPr txBox="1"/>
          <p:nvPr/>
        </p:nvSpPr>
        <p:spPr>
          <a:xfrm>
            <a:off x="476410" y="288351"/>
            <a:ext cx="230585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a) PGE</a:t>
            </a:r>
            <a:r>
              <a:rPr kumimoji="1" lang="en-US" altLang="ja-JP" sz="14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kumimoji="1"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</a:t>
            </a:r>
            <a:r>
              <a:rPr kumimoji="1" lang="en-US" altLang="ja-JP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g</a:t>
            </a:r>
            <a:r>
              <a:rPr kumimoji="1"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/mL)</a:t>
            </a:r>
            <a:endParaRPr kumimoji="1" lang="ja-JP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847F998F-4C07-4B5A-A9F3-01507E6D6A75}"/>
              </a:ext>
            </a:extLst>
          </p:cNvPr>
          <p:cNvSpPr txBox="1"/>
          <p:nvPr/>
        </p:nvSpPr>
        <p:spPr>
          <a:xfrm>
            <a:off x="3598050" y="295370"/>
            <a:ext cx="2373085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b) IFN-γ (</a:t>
            </a:r>
            <a:r>
              <a:rPr kumimoji="1" lang="en-US" altLang="ja-JP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g</a:t>
            </a:r>
            <a:r>
              <a:rPr kumimoji="1"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/mL): </a:t>
            </a:r>
          </a:p>
          <a:p>
            <a:r>
              <a:rPr kumimoji="1"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    response to Con A</a:t>
            </a:r>
            <a:endParaRPr kumimoji="1" lang="ja-JP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FDE252EE-D3A8-4DB5-8025-9A869134AB24}"/>
              </a:ext>
            </a:extLst>
          </p:cNvPr>
          <p:cNvSpPr txBox="1"/>
          <p:nvPr/>
        </p:nvSpPr>
        <p:spPr>
          <a:xfrm>
            <a:off x="476410" y="3000805"/>
            <a:ext cx="2601045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c) IFN-γ (</a:t>
            </a:r>
            <a:r>
              <a:rPr kumimoji="1" lang="en-US" altLang="ja-JP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g</a:t>
            </a:r>
            <a:r>
              <a:rPr kumimoji="1"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/mL): </a:t>
            </a:r>
          </a:p>
          <a:p>
            <a:r>
              <a:rPr kumimoji="1"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   response to BLV antigen</a:t>
            </a:r>
            <a:endParaRPr kumimoji="1" lang="ja-JP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" name="テキスト ボックス 10">
            <a:extLst>
              <a:ext uri="{FF2B5EF4-FFF2-40B4-BE49-F238E27FC236}">
                <a16:creationId xmlns:a16="http://schemas.microsoft.com/office/drawing/2014/main" id="{182492F5-D548-4006-A7D9-7D539CD3BF35}"/>
              </a:ext>
            </a:extLst>
          </p:cNvPr>
          <p:cNvSpPr txBox="1"/>
          <p:nvPr/>
        </p:nvSpPr>
        <p:spPr>
          <a:xfrm>
            <a:off x="3598050" y="3000805"/>
            <a:ext cx="230585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d) Estradiol (</a:t>
            </a:r>
            <a:r>
              <a:rPr kumimoji="1" lang="en-US" altLang="ja-JP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g</a:t>
            </a:r>
            <a:r>
              <a:rPr kumimoji="1"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/mL)</a:t>
            </a:r>
            <a:endParaRPr kumimoji="1" lang="ja-JP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" name="テキスト ボックス 11">
            <a:extLst>
              <a:ext uri="{FF2B5EF4-FFF2-40B4-BE49-F238E27FC236}">
                <a16:creationId xmlns:a16="http://schemas.microsoft.com/office/drawing/2014/main" id="{388C4F0B-C68F-487B-8066-CF13BA86AD47}"/>
              </a:ext>
            </a:extLst>
          </p:cNvPr>
          <p:cNvSpPr txBox="1"/>
          <p:nvPr/>
        </p:nvSpPr>
        <p:spPr>
          <a:xfrm>
            <a:off x="273050" y="5439988"/>
            <a:ext cx="6311900" cy="1015663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sz="1200" b="1" dirty="0">
                <a:cs typeface="Times New Roman" panose="02020603050405020304" pitchFamily="18" charset="0"/>
              </a:rPr>
              <a:t>Supplementary Table 2.</a:t>
            </a:r>
          </a:p>
          <a:p>
            <a:r>
              <a:rPr lang="en-US" altLang="ja-JP" sz="1200" dirty="0">
                <a:cs typeface="Times New Roman" panose="02020603050405020304" pitchFamily="18" charset="0"/>
              </a:rPr>
              <a:t>The original data of analyses of BLV-infected pregnant cattle </a:t>
            </a:r>
            <a:r>
              <a:rPr lang="pt-BR" altLang="ja-JP" sz="1200" dirty="0">
                <a:cs typeface="Times New Roman" panose="02020603050405020304" pitchFamily="18" charset="0"/>
              </a:rPr>
              <a:t>(animals #1–#5)</a:t>
            </a:r>
            <a:r>
              <a:rPr lang="en-US" altLang="ja-JP" sz="1200" dirty="0">
                <a:cs typeface="Times New Roman" panose="02020603050405020304" pitchFamily="18" charset="0"/>
              </a:rPr>
              <a:t>, related to Figure 2.</a:t>
            </a:r>
          </a:p>
          <a:p>
            <a:r>
              <a:rPr lang="en-US" altLang="ja-JP" sz="1200" dirty="0">
                <a:cs typeface="Times New Roman" panose="02020603050405020304" pitchFamily="18" charset="0"/>
              </a:rPr>
              <a:t>(a) The concentrations of PGE</a:t>
            </a:r>
            <a:r>
              <a:rPr lang="en-US" altLang="ja-JP" sz="1200" baseline="-25000" dirty="0">
                <a:cs typeface="Times New Roman" panose="02020603050405020304" pitchFamily="18" charset="0"/>
              </a:rPr>
              <a:t>2</a:t>
            </a:r>
            <a:r>
              <a:rPr lang="en-US" altLang="ja-JP" sz="1200" dirty="0">
                <a:cs typeface="Times New Roman" panose="02020603050405020304" pitchFamily="18" charset="0"/>
              </a:rPr>
              <a:t> in the sera. (b and c) IFN-γ production in response to Con A (b) or gp51 peptide mix (c) in the whole-blood cultures (b) or PBMC cultures (c). (d) The concentrations of estradiol in the sera. </a:t>
            </a:r>
          </a:p>
        </p:txBody>
      </p:sp>
    </p:spTree>
    <p:extLst>
      <p:ext uri="{BB962C8B-B14F-4D97-AF65-F5344CB8AC3E}">
        <p14:creationId xmlns:p14="http://schemas.microsoft.com/office/powerpoint/2010/main" val="217650032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Paper format">
      <a:majorFont>
        <a:latin typeface="Times New Roman"/>
        <a:ea typeface="ＭＳ 明朝"/>
        <a:cs typeface=""/>
      </a:majorFont>
      <a:minorFont>
        <a:latin typeface="Times New Roman"/>
        <a:ea typeface="ＭＳ 明朝"/>
        <a:cs typeface="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36</TotalTime>
  <Words>221</Words>
  <Application>Microsoft Office PowerPoint</Application>
  <PresentationFormat>On-screen Show (4:3)</PresentationFormat>
  <Paragraphs>93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4" baseType="lpstr">
      <vt:lpstr>Arial</vt:lpstr>
      <vt:lpstr>Times New Roman</vt:lpstr>
      <vt:lpstr>Office テーマ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佐治木 大和</dc:creator>
  <cp:lastModifiedBy>Saranya Siva</cp:lastModifiedBy>
  <cp:revision>7</cp:revision>
  <dcterms:created xsi:type="dcterms:W3CDTF">2021-12-25T03:57:05Z</dcterms:created>
  <dcterms:modified xsi:type="dcterms:W3CDTF">2022-02-15T03:42:28Z</dcterms:modified>
</cp:coreProperties>
</file>